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60"/>
  </p:normalViewPr>
  <p:slideViewPr>
    <p:cSldViewPr>
      <p:cViewPr>
        <p:scale>
          <a:sx n="150" d="100"/>
          <a:sy n="150" d="100"/>
        </p:scale>
        <p:origin x="-1208" y="155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034535465298947"/>
          <c:y val="5.8171346052468306E-2"/>
          <c:w val="0.86808590134422525"/>
          <c:h val="0.68858092729372911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A$3</c:f>
              <c:strCache>
                <c:ptCount val="1"/>
                <c:pt idx="0">
                  <c:v>Asian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c:spPr>
          <c:invertIfNegative val="0"/>
          <c:dPt>
            <c:idx val="19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</a:ln>
            </c:spPr>
          </c:dPt>
          <c:cat>
            <c:multiLvlStrRef>
              <c:f>Sheet1!$B$1:$BU$2</c:f>
              <c:multiLvlStrCache>
                <c:ptCount val="72"/>
                <c:lvl>
                  <c:pt idx="0">
                    <c:v>Jan.</c:v>
                  </c:pt>
                  <c:pt idx="1">
                    <c:v>Feb.</c:v>
                  </c:pt>
                  <c:pt idx="2">
                    <c:v>Mar.</c:v>
                  </c:pt>
                  <c:pt idx="3">
                    <c:v>Apr.</c:v>
                  </c:pt>
                  <c:pt idx="4">
                    <c:v>May.</c:v>
                  </c:pt>
                  <c:pt idx="5">
                    <c:v>June</c:v>
                  </c:pt>
                  <c:pt idx="6">
                    <c:v>July.</c:v>
                  </c:pt>
                  <c:pt idx="7">
                    <c:v>Aug.</c:v>
                  </c:pt>
                  <c:pt idx="8">
                    <c:v>Sep.</c:v>
                  </c:pt>
                  <c:pt idx="9">
                    <c:v>Oct.</c:v>
                  </c:pt>
                  <c:pt idx="10">
                    <c:v>Nov.</c:v>
                  </c:pt>
                  <c:pt idx="11">
                    <c:v>Dec.</c:v>
                  </c:pt>
                  <c:pt idx="12">
                    <c:v>Jan.</c:v>
                  </c:pt>
                  <c:pt idx="13">
                    <c:v>Feb.</c:v>
                  </c:pt>
                  <c:pt idx="14">
                    <c:v>Mar.</c:v>
                  </c:pt>
                  <c:pt idx="15">
                    <c:v>Apr.</c:v>
                  </c:pt>
                  <c:pt idx="16">
                    <c:v>May.</c:v>
                  </c:pt>
                  <c:pt idx="17">
                    <c:v>June</c:v>
                  </c:pt>
                  <c:pt idx="18">
                    <c:v>July.</c:v>
                  </c:pt>
                  <c:pt idx="19">
                    <c:v>Aug.</c:v>
                  </c:pt>
                  <c:pt idx="20">
                    <c:v>Sep.</c:v>
                  </c:pt>
                  <c:pt idx="21">
                    <c:v>Oct.</c:v>
                  </c:pt>
                  <c:pt idx="22">
                    <c:v>Nov.</c:v>
                  </c:pt>
                  <c:pt idx="23">
                    <c:v>Dec.</c:v>
                  </c:pt>
                  <c:pt idx="24">
                    <c:v>Jan.</c:v>
                  </c:pt>
                  <c:pt idx="25">
                    <c:v>Feb.</c:v>
                  </c:pt>
                  <c:pt idx="26">
                    <c:v>Mar.</c:v>
                  </c:pt>
                  <c:pt idx="27">
                    <c:v>Apr.</c:v>
                  </c:pt>
                  <c:pt idx="28">
                    <c:v>May.</c:v>
                  </c:pt>
                  <c:pt idx="29">
                    <c:v>June</c:v>
                  </c:pt>
                  <c:pt idx="30">
                    <c:v>July.</c:v>
                  </c:pt>
                  <c:pt idx="31">
                    <c:v>Aug.</c:v>
                  </c:pt>
                  <c:pt idx="32">
                    <c:v>Sep.</c:v>
                  </c:pt>
                  <c:pt idx="33">
                    <c:v>Oct.</c:v>
                  </c:pt>
                  <c:pt idx="34">
                    <c:v>Nov.</c:v>
                  </c:pt>
                  <c:pt idx="35">
                    <c:v>Dec.</c:v>
                  </c:pt>
                  <c:pt idx="36">
                    <c:v>Jan.</c:v>
                  </c:pt>
                  <c:pt idx="37">
                    <c:v>Feb.</c:v>
                  </c:pt>
                  <c:pt idx="38">
                    <c:v>Mar.</c:v>
                  </c:pt>
                  <c:pt idx="39">
                    <c:v>Apr.</c:v>
                  </c:pt>
                  <c:pt idx="40">
                    <c:v>May.</c:v>
                  </c:pt>
                  <c:pt idx="41">
                    <c:v>June</c:v>
                  </c:pt>
                  <c:pt idx="42">
                    <c:v>July.</c:v>
                  </c:pt>
                  <c:pt idx="43">
                    <c:v>Aug.</c:v>
                  </c:pt>
                  <c:pt idx="44">
                    <c:v>Sep.</c:v>
                  </c:pt>
                  <c:pt idx="45">
                    <c:v>Oct.</c:v>
                  </c:pt>
                  <c:pt idx="46">
                    <c:v>Nov.</c:v>
                  </c:pt>
                  <c:pt idx="47">
                    <c:v>Dec.</c:v>
                  </c:pt>
                  <c:pt idx="48">
                    <c:v>Jan.</c:v>
                  </c:pt>
                  <c:pt idx="49">
                    <c:v>Feb.</c:v>
                  </c:pt>
                  <c:pt idx="50">
                    <c:v>Mar.</c:v>
                  </c:pt>
                  <c:pt idx="51">
                    <c:v>Apr.</c:v>
                  </c:pt>
                  <c:pt idx="52">
                    <c:v>May.</c:v>
                  </c:pt>
                  <c:pt idx="53">
                    <c:v>June</c:v>
                  </c:pt>
                  <c:pt idx="54">
                    <c:v>July.</c:v>
                  </c:pt>
                  <c:pt idx="55">
                    <c:v>Aug.</c:v>
                  </c:pt>
                  <c:pt idx="56">
                    <c:v>Sep.</c:v>
                  </c:pt>
                  <c:pt idx="57">
                    <c:v>Oct.</c:v>
                  </c:pt>
                  <c:pt idx="58">
                    <c:v>Nov.</c:v>
                  </c:pt>
                  <c:pt idx="59">
                    <c:v>Dec.</c:v>
                  </c:pt>
                  <c:pt idx="60">
                    <c:v>Jan.</c:v>
                  </c:pt>
                  <c:pt idx="61">
                    <c:v>Feb.</c:v>
                  </c:pt>
                  <c:pt idx="62">
                    <c:v>Mar.</c:v>
                  </c:pt>
                  <c:pt idx="63">
                    <c:v>Apr.</c:v>
                  </c:pt>
                  <c:pt idx="64">
                    <c:v>May.</c:v>
                  </c:pt>
                  <c:pt idx="65">
                    <c:v>June</c:v>
                  </c:pt>
                  <c:pt idx="66">
                    <c:v>July.</c:v>
                  </c:pt>
                  <c:pt idx="67">
                    <c:v>Aug.</c:v>
                  </c:pt>
                  <c:pt idx="68">
                    <c:v>Sep.</c:v>
                  </c:pt>
                  <c:pt idx="69">
                    <c:v>Oct.</c:v>
                  </c:pt>
                  <c:pt idx="70">
                    <c:v>Nov.</c:v>
                  </c:pt>
                  <c:pt idx="71">
                    <c:v>Dec.</c:v>
                  </c:pt>
                </c:lvl>
                <c:lvl>
                  <c:pt idx="0">
                    <c:v>2016</c:v>
                  </c:pt>
                  <c:pt idx="12">
                    <c:v>2017</c:v>
                  </c:pt>
                  <c:pt idx="24">
                    <c:v>2018</c:v>
                  </c:pt>
                  <c:pt idx="36">
                    <c:v>2019</c:v>
                  </c:pt>
                  <c:pt idx="48">
                    <c:v>2020</c:v>
                  </c:pt>
                  <c:pt idx="60">
                    <c:v>2021</c:v>
                  </c:pt>
                </c:lvl>
              </c:multiLvlStrCache>
            </c:multiLvlStrRef>
          </c:cat>
          <c:val>
            <c:numRef>
              <c:f>Sheet1!$B$3:$BU$3</c:f>
              <c:numCache>
                <c:formatCode>_(* #,##0_);_(* \(#,##0\);_(* "-"_);_(@_)</c:formatCode>
                <c:ptCount val="72"/>
                <c:pt idx="0">
                  <c:v>1627068</c:v>
                </c:pt>
                <c:pt idx="1">
                  <c:v>1661398</c:v>
                </c:pt>
                <c:pt idx="2">
                  <c:v>1629434</c:v>
                </c:pt>
                <c:pt idx="3">
                  <c:v>1690796</c:v>
                </c:pt>
                <c:pt idx="4">
                  <c:v>1468474</c:v>
                </c:pt>
                <c:pt idx="5">
                  <c:v>1550057</c:v>
                </c:pt>
                <c:pt idx="6">
                  <c:v>1805247</c:v>
                </c:pt>
                <c:pt idx="7">
                  <c:v>1647948</c:v>
                </c:pt>
                <c:pt idx="8">
                  <c:v>1512841</c:v>
                </c:pt>
                <c:pt idx="9">
                  <c:v>1650321</c:v>
                </c:pt>
                <c:pt idx="10">
                  <c:v>1519950</c:v>
                </c:pt>
                <c:pt idx="11">
                  <c:v>1687866</c:v>
                </c:pt>
                <c:pt idx="12" formatCode="General">
                  <c:v>1997437</c:v>
                </c:pt>
                <c:pt idx="13" formatCode="General">
                  <c:v>1752810</c:v>
                </c:pt>
                <c:pt idx="14" formatCode="General">
                  <c:v>1788372</c:v>
                </c:pt>
                <c:pt idx="15" formatCode="General">
                  <c:v>2035461</c:v>
                </c:pt>
                <c:pt idx="16" formatCode="General">
                  <c:v>1853698</c:v>
                </c:pt>
                <c:pt idx="17" formatCode="General">
                  <c:v>1850052</c:v>
                </c:pt>
                <c:pt idx="18" formatCode="General">
                  <c:v>2110277</c:v>
                </c:pt>
                <c:pt idx="19" formatCode="General">
                  <c:v>1999173</c:v>
                </c:pt>
                <c:pt idx="20" formatCode="General">
                  <c:v>1804870</c:v>
                </c:pt>
                <c:pt idx="21" formatCode="General">
                  <c:v>2042481</c:v>
                </c:pt>
                <c:pt idx="22" formatCode="General">
                  <c:v>1953006</c:v>
                </c:pt>
                <c:pt idx="23" formatCode="General">
                  <c:v>2089910</c:v>
                </c:pt>
                <c:pt idx="24" formatCode="General">
                  <c:v>2147314</c:v>
                </c:pt>
                <c:pt idx="25" formatCode="General">
                  <c:v>2154067</c:v>
                </c:pt>
                <c:pt idx="26" formatCode="General">
                  <c:v>2129852</c:v>
                </c:pt>
                <c:pt idx="27" formatCode="General">
                  <c:v>2321195</c:v>
                </c:pt>
                <c:pt idx="28" formatCode="General">
                  <c:v>2155640</c:v>
                </c:pt>
                <c:pt idx="29" formatCode="General">
                  <c:v>2171531</c:v>
                </c:pt>
                <c:pt idx="30" formatCode="General">
                  <c:v>2231854</c:v>
                </c:pt>
                <c:pt idx="31" formatCode="General">
                  <c:v>2112838</c:v>
                </c:pt>
                <c:pt idx="32" formatCode="General">
                  <c:v>1696376</c:v>
                </c:pt>
                <c:pt idx="33" formatCode="#,##0">
                  <c:v>2091086</c:v>
                </c:pt>
                <c:pt idx="34" formatCode="General">
                  <c:v>2038581</c:v>
                </c:pt>
                <c:pt idx="35" formatCode="General">
                  <c:v>2234370</c:v>
                </c:pt>
                <c:pt idx="36" formatCode="General">
                  <c:v>2358452</c:v>
                </c:pt>
                <c:pt idx="37" formatCode="General">
                  <c:v>2288283</c:v>
                </c:pt>
                <c:pt idx="38" formatCode="General">
                  <c:v>2274609</c:v>
                </c:pt>
                <c:pt idx="39" formatCode="General">
                  <c:v>2316171</c:v>
                </c:pt>
                <c:pt idx="40" formatCode="General">
                  <c:v>2295773</c:v>
                </c:pt>
                <c:pt idx="41" formatCode="General">
                  <c:v>2340400</c:v>
                </c:pt>
                <c:pt idx="42" formatCode="General">
                  <c:v>2382612</c:v>
                </c:pt>
                <c:pt idx="43" formatCode="General">
                  <c:v>2039889</c:v>
                </c:pt>
                <c:pt idx="44" formatCode="General">
                  <c:v>1742625</c:v>
                </c:pt>
                <c:pt idx="45" formatCode="General">
                  <c:v>1892754</c:v>
                </c:pt>
                <c:pt idx="46" formatCode="General">
                  <c:v>1938621</c:v>
                </c:pt>
                <c:pt idx="47" formatCode="General">
                  <c:v>2055377</c:v>
                </c:pt>
                <c:pt idx="48" formatCode="General">
                  <c:v>2308263</c:v>
                </c:pt>
                <c:pt idx="49" formatCode="General">
                  <c:v>890951</c:v>
                </c:pt>
                <c:pt idx="50" formatCode="General">
                  <c:v>124682</c:v>
                </c:pt>
                <c:pt idx="51" formatCode="General">
                  <c:v>4034</c:v>
                </c:pt>
                <c:pt idx="52" formatCode="General">
                  <c:v>3766</c:v>
                </c:pt>
                <c:pt idx="53" formatCode="General">
                  <c:v>6754</c:v>
                </c:pt>
                <c:pt idx="54" formatCode="General">
                  <c:v>8241</c:v>
                </c:pt>
                <c:pt idx="55" formatCode="General">
                  <c:v>11868</c:v>
                </c:pt>
                <c:pt idx="56" formatCode="General">
                  <c:v>15724</c:v>
                </c:pt>
                <c:pt idx="57" formatCode="General">
                  <c:v>29220</c:v>
                </c:pt>
                <c:pt idx="58" formatCode="General">
                  <c:v>58669</c:v>
                </c:pt>
                <c:pt idx="59" formatCode="General">
                  <c:v>61868</c:v>
                </c:pt>
                <c:pt idx="60" formatCode="General">
                  <c:v>48317</c:v>
                </c:pt>
                <c:pt idx="61" formatCode="General">
                  <c:v>10870</c:v>
                </c:pt>
                <c:pt idx="62" formatCode="General">
                  <c:v>15565</c:v>
                </c:pt>
                <c:pt idx="63" formatCode="General">
                  <c:v>13303</c:v>
                </c:pt>
                <c:pt idx="64" formatCode="General">
                  <c:v>12163</c:v>
                </c:pt>
                <c:pt idx="65" formatCode="General">
                  <c:v>11245</c:v>
                </c:pt>
                <c:pt idx="66" formatCode="General">
                  <c:v>16777</c:v>
                </c:pt>
                <c:pt idx="67" formatCode="General">
                  <c:v>14123</c:v>
                </c:pt>
                <c:pt idx="68" formatCode="General">
                  <c:v>18634</c:v>
                </c:pt>
                <c:pt idx="69" formatCode="General">
                  <c:v>22712</c:v>
                </c:pt>
                <c:pt idx="70" formatCode="General">
                  <c:v>23611</c:v>
                </c:pt>
                <c:pt idx="71" formatCode="General">
                  <c:v>17612</c:v>
                </c:pt>
              </c:numCache>
            </c:numRef>
          </c:val>
        </c:ser>
        <c:ser>
          <c:idx val="1"/>
          <c:order val="1"/>
          <c:tx>
            <c:strRef>
              <c:f>Sheet1!$A$4</c:f>
              <c:strCache>
                <c:ptCount val="1"/>
                <c:pt idx="0">
                  <c:v>Non-Asian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multiLvlStrRef>
              <c:f>Sheet1!$B$1:$BU$2</c:f>
              <c:multiLvlStrCache>
                <c:ptCount val="72"/>
                <c:lvl>
                  <c:pt idx="0">
                    <c:v>Jan.</c:v>
                  </c:pt>
                  <c:pt idx="1">
                    <c:v>Feb.</c:v>
                  </c:pt>
                  <c:pt idx="2">
                    <c:v>Mar.</c:v>
                  </c:pt>
                  <c:pt idx="3">
                    <c:v>Apr.</c:v>
                  </c:pt>
                  <c:pt idx="4">
                    <c:v>May.</c:v>
                  </c:pt>
                  <c:pt idx="5">
                    <c:v>June</c:v>
                  </c:pt>
                  <c:pt idx="6">
                    <c:v>July.</c:v>
                  </c:pt>
                  <c:pt idx="7">
                    <c:v>Aug.</c:v>
                  </c:pt>
                  <c:pt idx="8">
                    <c:v>Sep.</c:v>
                  </c:pt>
                  <c:pt idx="9">
                    <c:v>Oct.</c:v>
                  </c:pt>
                  <c:pt idx="10">
                    <c:v>Nov.</c:v>
                  </c:pt>
                  <c:pt idx="11">
                    <c:v>Dec.</c:v>
                  </c:pt>
                  <c:pt idx="12">
                    <c:v>Jan.</c:v>
                  </c:pt>
                  <c:pt idx="13">
                    <c:v>Feb.</c:v>
                  </c:pt>
                  <c:pt idx="14">
                    <c:v>Mar.</c:v>
                  </c:pt>
                  <c:pt idx="15">
                    <c:v>Apr.</c:v>
                  </c:pt>
                  <c:pt idx="16">
                    <c:v>May.</c:v>
                  </c:pt>
                  <c:pt idx="17">
                    <c:v>June</c:v>
                  </c:pt>
                  <c:pt idx="18">
                    <c:v>July.</c:v>
                  </c:pt>
                  <c:pt idx="19">
                    <c:v>Aug.</c:v>
                  </c:pt>
                  <c:pt idx="20">
                    <c:v>Sep.</c:v>
                  </c:pt>
                  <c:pt idx="21">
                    <c:v>Oct.</c:v>
                  </c:pt>
                  <c:pt idx="22">
                    <c:v>Nov.</c:v>
                  </c:pt>
                  <c:pt idx="23">
                    <c:v>Dec.</c:v>
                  </c:pt>
                  <c:pt idx="24">
                    <c:v>Jan.</c:v>
                  </c:pt>
                  <c:pt idx="25">
                    <c:v>Feb.</c:v>
                  </c:pt>
                  <c:pt idx="26">
                    <c:v>Mar.</c:v>
                  </c:pt>
                  <c:pt idx="27">
                    <c:v>Apr.</c:v>
                  </c:pt>
                  <c:pt idx="28">
                    <c:v>May.</c:v>
                  </c:pt>
                  <c:pt idx="29">
                    <c:v>June</c:v>
                  </c:pt>
                  <c:pt idx="30">
                    <c:v>July.</c:v>
                  </c:pt>
                  <c:pt idx="31">
                    <c:v>Aug.</c:v>
                  </c:pt>
                  <c:pt idx="32">
                    <c:v>Sep.</c:v>
                  </c:pt>
                  <c:pt idx="33">
                    <c:v>Oct.</c:v>
                  </c:pt>
                  <c:pt idx="34">
                    <c:v>Nov.</c:v>
                  </c:pt>
                  <c:pt idx="35">
                    <c:v>Dec.</c:v>
                  </c:pt>
                  <c:pt idx="36">
                    <c:v>Jan.</c:v>
                  </c:pt>
                  <c:pt idx="37">
                    <c:v>Feb.</c:v>
                  </c:pt>
                  <c:pt idx="38">
                    <c:v>Mar.</c:v>
                  </c:pt>
                  <c:pt idx="39">
                    <c:v>Apr.</c:v>
                  </c:pt>
                  <c:pt idx="40">
                    <c:v>May.</c:v>
                  </c:pt>
                  <c:pt idx="41">
                    <c:v>June</c:v>
                  </c:pt>
                  <c:pt idx="42">
                    <c:v>July.</c:v>
                  </c:pt>
                  <c:pt idx="43">
                    <c:v>Aug.</c:v>
                  </c:pt>
                  <c:pt idx="44">
                    <c:v>Sep.</c:v>
                  </c:pt>
                  <c:pt idx="45">
                    <c:v>Oct.</c:v>
                  </c:pt>
                  <c:pt idx="46">
                    <c:v>Nov.</c:v>
                  </c:pt>
                  <c:pt idx="47">
                    <c:v>Dec.</c:v>
                  </c:pt>
                  <c:pt idx="48">
                    <c:v>Jan.</c:v>
                  </c:pt>
                  <c:pt idx="49">
                    <c:v>Feb.</c:v>
                  </c:pt>
                  <c:pt idx="50">
                    <c:v>Mar.</c:v>
                  </c:pt>
                  <c:pt idx="51">
                    <c:v>Apr.</c:v>
                  </c:pt>
                  <c:pt idx="52">
                    <c:v>May.</c:v>
                  </c:pt>
                  <c:pt idx="53">
                    <c:v>June</c:v>
                  </c:pt>
                  <c:pt idx="54">
                    <c:v>July.</c:v>
                  </c:pt>
                  <c:pt idx="55">
                    <c:v>Aug.</c:v>
                  </c:pt>
                  <c:pt idx="56">
                    <c:v>Sep.</c:v>
                  </c:pt>
                  <c:pt idx="57">
                    <c:v>Oct.</c:v>
                  </c:pt>
                  <c:pt idx="58">
                    <c:v>Nov.</c:v>
                  </c:pt>
                  <c:pt idx="59">
                    <c:v>Dec.</c:v>
                  </c:pt>
                  <c:pt idx="60">
                    <c:v>Jan.</c:v>
                  </c:pt>
                  <c:pt idx="61">
                    <c:v>Feb.</c:v>
                  </c:pt>
                  <c:pt idx="62">
                    <c:v>Mar.</c:v>
                  </c:pt>
                  <c:pt idx="63">
                    <c:v>Apr.</c:v>
                  </c:pt>
                  <c:pt idx="64">
                    <c:v>May.</c:v>
                  </c:pt>
                  <c:pt idx="65">
                    <c:v>June</c:v>
                  </c:pt>
                  <c:pt idx="66">
                    <c:v>July.</c:v>
                  </c:pt>
                  <c:pt idx="67">
                    <c:v>Aug.</c:v>
                  </c:pt>
                  <c:pt idx="68">
                    <c:v>Sep.</c:v>
                  </c:pt>
                  <c:pt idx="69">
                    <c:v>Oct.</c:v>
                  </c:pt>
                  <c:pt idx="70">
                    <c:v>Nov.</c:v>
                  </c:pt>
                  <c:pt idx="71">
                    <c:v>Dec.</c:v>
                  </c:pt>
                </c:lvl>
                <c:lvl>
                  <c:pt idx="0">
                    <c:v>2016</c:v>
                  </c:pt>
                  <c:pt idx="12">
                    <c:v>2017</c:v>
                  </c:pt>
                  <c:pt idx="24">
                    <c:v>2018</c:v>
                  </c:pt>
                  <c:pt idx="36">
                    <c:v>2019</c:v>
                  </c:pt>
                  <c:pt idx="48">
                    <c:v>2020</c:v>
                  </c:pt>
                  <c:pt idx="60">
                    <c:v>2021</c:v>
                  </c:pt>
                </c:lvl>
              </c:multiLvlStrCache>
            </c:multiLvlStrRef>
          </c:cat>
          <c:val>
            <c:numRef>
              <c:f>Sheet1!$B$4:$BU$4</c:f>
              <c:numCache>
                <c:formatCode>General</c:formatCode>
                <c:ptCount val="72"/>
                <c:pt idx="0">
                  <c:v>262072</c:v>
                </c:pt>
                <c:pt idx="1">
                  <c:v>229005</c:v>
                </c:pt>
                <c:pt idx="2">
                  <c:v>362986</c:v>
                </c:pt>
                <c:pt idx="3">
                  <c:v>353061</c:v>
                </c:pt>
                <c:pt idx="4">
                  <c:v>317902</c:v>
                </c:pt>
                <c:pt idx="5">
                  <c:v>304091</c:v>
                </c:pt>
                <c:pt idx="6">
                  <c:v>339513</c:v>
                </c:pt>
                <c:pt idx="7">
                  <c:v>292054</c:v>
                </c:pt>
                <c:pt idx="8">
                  <c:v>316497</c:v>
                </c:pt>
                <c:pt idx="9">
                  <c:v>383051</c:v>
                </c:pt>
                <c:pt idx="10">
                  <c:v>296658</c:v>
                </c:pt>
                <c:pt idx="11">
                  <c:v>310622</c:v>
                </c:pt>
                <c:pt idx="12">
                  <c:v>297480</c:v>
                </c:pt>
                <c:pt idx="13">
                  <c:v>245154</c:v>
                </c:pt>
                <c:pt idx="14">
                  <c:v>375997</c:v>
                </c:pt>
                <c:pt idx="15">
                  <c:v>459901</c:v>
                </c:pt>
                <c:pt idx="16">
                  <c:v>353282</c:v>
                </c:pt>
                <c:pt idx="17">
                  <c:v>325834</c:v>
                </c:pt>
                <c:pt idx="18">
                  <c:v>368126</c:v>
                </c:pt>
                <c:pt idx="19">
                  <c:v>305824</c:v>
                </c:pt>
                <c:pt idx="20">
                  <c:v>336848</c:v>
                </c:pt>
                <c:pt idx="21">
                  <c:v>407362</c:v>
                </c:pt>
                <c:pt idx="22">
                  <c:v>336076</c:v>
                </c:pt>
                <c:pt idx="23">
                  <c:v>339351</c:v>
                </c:pt>
                <c:pt idx="24">
                  <c:v>318838</c:v>
                </c:pt>
                <c:pt idx="25">
                  <c:v>274415</c:v>
                </c:pt>
                <c:pt idx="26">
                  <c:v>447887</c:v>
                </c:pt>
                <c:pt idx="27">
                  <c:v>482583</c:v>
                </c:pt>
                <c:pt idx="28">
                  <c:v>406688</c:v>
                </c:pt>
                <c:pt idx="29">
                  <c:v>378620</c:v>
                </c:pt>
                <c:pt idx="30">
                  <c:v>416047</c:v>
                </c:pt>
                <c:pt idx="31">
                  <c:v>343546</c:v>
                </c:pt>
                <c:pt idx="32">
                  <c:v>359852</c:v>
                </c:pt>
                <c:pt idx="33">
                  <c:v>458220</c:v>
                </c:pt>
                <c:pt idx="34">
                  <c:v>366353</c:v>
                </c:pt>
                <c:pt idx="35">
                  <c:v>364349</c:v>
                </c:pt>
                <c:pt idx="36">
                  <c:v>344108</c:v>
                </c:pt>
                <c:pt idx="37">
                  <c:v>293487</c:v>
                </c:pt>
                <c:pt idx="38">
                  <c:v>477585</c:v>
                </c:pt>
                <c:pt idx="39">
                  <c:v>569285</c:v>
                </c:pt>
                <c:pt idx="40">
                  <c:v>447046</c:v>
                </c:pt>
                <c:pt idx="41">
                  <c:v>413583</c:v>
                </c:pt>
                <c:pt idx="42">
                  <c:v>442165</c:v>
                </c:pt>
                <c:pt idx="43">
                  <c:v>385941</c:v>
                </c:pt>
                <c:pt idx="44">
                  <c:v>466375</c:v>
                </c:pt>
                <c:pt idx="45">
                  <c:v>548858</c:v>
                </c:pt>
                <c:pt idx="46">
                  <c:v>446116</c:v>
                </c:pt>
                <c:pt idx="47">
                  <c:v>427064</c:v>
                </c:pt>
                <c:pt idx="48">
                  <c:v>390561</c:v>
                </c:pt>
                <c:pt idx="49">
                  <c:v>265009</c:v>
                </c:pt>
                <c:pt idx="50">
                  <c:v>92997</c:v>
                </c:pt>
                <c:pt idx="51">
                  <c:v>1278</c:v>
                </c:pt>
                <c:pt idx="52">
                  <c:v>722</c:v>
                </c:pt>
                <c:pt idx="53">
                  <c:v>1274</c:v>
                </c:pt>
                <c:pt idx="54">
                  <c:v>2059</c:v>
                </c:pt>
                <c:pt idx="55">
                  <c:v>4014</c:v>
                </c:pt>
                <c:pt idx="56">
                  <c:v>3137</c:v>
                </c:pt>
                <c:pt idx="57">
                  <c:v>6358</c:v>
                </c:pt>
                <c:pt idx="58">
                  <c:v>7934</c:v>
                </c:pt>
                <c:pt idx="59">
                  <c:v>7874</c:v>
                </c:pt>
                <c:pt idx="60">
                  <c:v>7401</c:v>
                </c:pt>
                <c:pt idx="61">
                  <c:v>2962</c:v>
                </c:pt>
                <c:pt idx="62">
                  <c:v>3833</c:v>
                </c:pt>
                <c:pt idx="63">
                  <c:v>4255</c:v>
                </c:pt>
                <c:pt idx="64">
                  <c:v>5213</c:v>
                </c:pt>
                <c:pt idx="65">
                  <c:v>6040</c:v>
                </c:pt>
                <c:pt idx="66">
                  <c:v>42688</c:v>
                </c:pt>
                <c:pt idx="67">
                  <c:v>20842</c:v>
                </c:pt>
                <c:pt idx="68">
                  <c:v>9122</c:v>
                </c:pt>
                <c:pt idx="69">
                  <c:v>10516</c:v>
                </c:pt>
                <c:pt idx="70">
                  <c:v>9140</c:v>
                </c:pt>
                <c:pt idx="71">
                  <c:v>61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0"/>
        <c:overlap val="100"/>
        <c:serLines/>
        <c:axId val="130948480"/>
        <c:axId val="130962560"/>
      </c:barChart>
      <c:catAx>
        <c:axId val="13094848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bg1">
                <a:lumMod val="85000"/>
              </a:schemeClr>
            </a:solidFill>
          </a:ln>
        </c:spPr>
        <c:txPr>
          <a:bodyPr/>
          <a:lstStyle/>
          <a:p>
            <a:pPr>
              <a:defRPr>
                <a:latin typeface="Arial Narrow" pitchFamily="34" charset="0"/>
              </a:defRPr>
            </a:pPr>
            <a:endParaRPr lang="ja-JP"/>
          </a:p>
        </c:txPr>
        <c:crossAx val="130962560"/>
        <c:crosses val="autoZero"/>
        <c:auto val="1"/>
        <c:lblAlgn val="ctr"/>
        <c:lblOffset val="100"/>
        <c:noMultiLvlLbl val="0"/>
      </c:catAx>
      <c:valAx>
        <c:axId val="130962560"/>
        <c:scaling>
          <c:orientation val="minMax"/>
        </c:scaling>
        <c:delete val="0"/>
        <c:axPos val="l"/>
        <c:numFmt formatCode="_(* #,##0_);_(* \(#,##0\);_(* &quot;-&quot;_);_(@_)" sourceLinked="1"/>
        <c:majorTickMark val="out"/>
        <c:minorTickMark val="none"/>
        <c:tickLblPos val="nextTo"/>
        <c:spPr>
          <a:ln>
            <a:solidFill>
              <a:schemeClr val="bg1">
                <a:lumMod val="65000"/>
              </a:schemeClr>
            </a:solidFill>
          </a:ln>
        </c:spPr>
        <c:txPr>
          <a:bodyPr/>
          <a:lstStyle/>
          <a:p>
            <a:pPr>
              <a:defRPr>
                <a:latin typeface="Arial Narrow" pitchFamily="34" charset="0"/>
              </a:defRPr>
            </a:pPr>
            <a:endParaRPr lang="ja-JP"/>
          </a:p>
        </c:txPr>
        <c:crossAx val="130948480"/>
        <c:crosses val="autoZero"/>
        <c:crossBetween val="between"/>
      </c:valAx>
      <c:spPr>
        <a:solidFill>
          <a:schemeClr val="bg1">
            <a:lumMod val="95000"/>
          </a:schemeClr>
        </a:solidFill>
      </c:spPr>
    </c:plotArea>
    <c:legend>
      <c:legendPos val="r"/>
      <c:layout>
        <c:manualLayout>
          <c:xMode val="edge"/>
          <c:yMode val="edge"/>
          <c:x val="0.85687663898137478"/>
          <c:y val="8.6141894778569969E-2"/>
          <c:w val="0.11675745614035088"/>
          <c:h val="0.13087126582062275"/>
        </c:manualLayout>
      </c:layout>
      <c:overlay val="1"/>
      <c:txPr>
        <a:bodyPr/>
        <a:lstStyle/>
        <a:p>
          <a:pPr>
            <a:defRPr>
              <a:latin typeface="Arial Narrow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77801317095036E-2"/>
          <c:y val="4.0155722500360161E-2"/>
          <c:w val="0.89641029668478722"/>
          <c:h val="0.6718000891182983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ppl. Table 1'!$P$2</c:f>
              <c:strCache>
                <c:ptCount val="1"/>
                <c:pt idx="0">
                  <c:v>No. of container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bg2">
                  <a:lumMod val="25000"/>
                </a:schemeClr>
              </a:solidFill>
            </a:ln>
          </c:spPr>
          <c:invertIfNegative val="0"/>
          <c:cat>
            <c:multiLvlStrRef>
              <c:f>'Suppl. Table 1'!$N$3:$O$69</c:f>
              <c:multiLvlStrCache>
                <c:ptCount val="67"/>
                <c:lvl>
                  <c:pt idx="0">
                    <c:v>Jan.</c:v>
                  </c:pt>
                  <c:pt idx="1">
                    <c:v>Feb.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</c:v>
                  </c:pt>
                  <c:pt idx="46">
                    <c:v>Nov</c:v>
                  </c:pt>
                  <c:pt idx="47">
                    <c:v>Dec</c:v>
                  </c:pt>
                  <c:pt idx="48">
                    <c:v>Jan</c:v>
                  </c:pt>
                  <c:pt idx="49">
                    <c:v>Feb</c:v>
                  </c:pt>
                  <c:pt idx="50">
                    <c:v>Mar</c:v>
                  </c:pt>
                  <c:pt idx="51">
                    <c:v>Apr</c:v>
                  </c:pt>
                  <c:pt idx="52">
                    <c:v>May</c:v>
                  </c:pt>
                  <c:pt idx="53">
                    <c:v>Jun</c:v>
                  </c:pt>
                  <c:pt idx="54">
                    <c:v>Jul</c:v>
                  </c:pt>
                  <c:pt idx="55">
                    <c:v>Aug</c:v>
                  </c:pt>
                  <c:pt idx="56">
                    <c:v>Sep</c:v>
                  </c:pt>
                  <c:pt idx="57">
                    <c:v>Oct</c:v>
                  </c:pt>
                  <c:pt idx="58">
                    <c:v>Nov</c:v>
                  </c:pt>
                  <c:pt idx="59">
                    <c:v>Dec</c:v>
                  </c:pt>
                  <c:pt idx="60">
                    <c:v>Jan</c:v>
                  </c:pt>
                  <c:pt idx="61">
                    <c:v>Feb</c:v>
                  </c:pt>
                  <c:pt idx="62">
                    <c:v>Mar</c:v>
                  </c:pt>
                  <c:pt idx="63">
                    <c:v>Apr</c:v>
                  </c:pt>
                  <c:pt idx="64">
                    <c:v>May</c:v>
                  </c:pt>
                  <c:pt idx="65">
                    <c:v>Jun</c:v>
                  </c:pt>
                  <c:pt idx="66">
                    <c:v>Jul</c:v>
                  </c:pt>
                </c:lvl>
                <c:lvl>
                  <c:pt idx="0">
                    <c:v>2016</c:v>
                  </c:pt>
                  <c:pt idx="12">
                    <c:v>2017</c:v>
                  </c:pt>
                  <c:pt idx="24">
                    <c:v>2018</c:v>
                  </c:pt>
                  <c:pt idx="36">
                    <c:v>2019</c:v>
                  </c:pt>
                  <c:pt idx="48">
                    <c:v>2020</c:v>
                  </c:pt>
                  <c:pt idx="60">
                    <c:v>2021</c:v>
                  </c:pt>
                </c:lvl>
              </c:multiLvlStrCache>
            </c:multiLvlStrRef>
          </c:cat>
          <c:val>
            <c:numRef>
              <c:f>'Suppl. Table 1'!$P$3:$P$69</c:f>
              <c:numCache>
                <c:formatCode>General</c:formatCode>
                <c:ptCount val="67"/>
                <c:pt idx="0">
                  <c:v>656393</c:v>
                </c:pt>
                <c:pt idx="1">
                  <c:v>583602</c:v>
                </c:pt>
                <c:pt idx="2">
                  <c:v>720997</c:v>
                </c:pt>
                <c:pt idx="3">
                  <c:v>662222</c:v>
                </c:pt>
                <c:pt idx="4">
                  <c:v>671700</c:v>
                </c:pt>
                <c:pt idx="5">
                  <c:v>672816</c:v>
                </c:pt>
                <c:pt idx="6">
                  <c:v>680971</c:v>
                </c:pt>
                <c:pt idx="7">
                  <c:v>685061</c:v>
                </c:pt>
                <c:pt idx="8">
                  <c:v>692514</c:v>
                </c:pt>
                <c:pt idx="9">
                  <c:v>673536</c:v>
                </c:pt>
                <c:pt idx="10">
                  <c:v>735747</c:v>
                </c:pt>
                <c:pt idx="11">
                  <c:v>703251</c:v>
                </c:pt>
                <c:pt idx="12">
                  <c:v>723968</c:v>
                </c:pt>
                <c:pt idx="13">
                  <c:v>556497</c:v>
                </c:pt>
                <c:pt idx="14">
                  <c:v>769802</c:v>
                </c:pt>
                <c:pt idx="15">
                  <c:v>701746</c:v>
                </c:pt>
                <c:pt idx="16">
                  <c:v>732330</c:v>
                </c:pt>
                <c:pt idx="17">
                  <c:v>717636</c:v>
                </c:pt>
                <c:pt idx="18">
                  <c:v>723790</c:v>
                </c:pt>
                <c:pt idx="19">
                  <c:v>731618</c:v>
                </c:pt>
                <c:pt idx="20">
                  <c:v>716258</c:v>
                </c:pt>
                <c:pt idx="21">
                  <c:v>691489</c:v>
                </c:pt>
                <c:pt idx="22">
                  <c:v>791748</c:v>
                </c:pt>
                <c:pt idx="23">
                  <c:v>720797</c:v>
                </c:pt>
                <c:pt idx="24">
                  <c:v>723452</c:v>
                </c:pt>
                <c:pt idx="25">
                  <c:v>677837</c:v>
                </c:pt>
                <c:pt idx="26">
                  <c:v>707444</c:v>
                </c:pt>
                <c:pt idx="27">
                  <c:v>727018</c:v>
                </c:pt>
                <c:pt idx="28">
                  <c:v>764479</c:v>
                </c:pt>
                <c:pt idx="29">
                  <c:v>714087</c:v>
                </c:pt>
                <c:pt idx="30">
                  <c:v>726086</c:v>
                </c:pt>
                <c:pt idx="31">
                  <c:v>729639</c:v>
                </c:pt>
                <c:pt idx="32">
                  <c:v>729476</c:v>
                </c:pt>
                <c:pt idx="33">
                  <c:v>783373</c:v>
                </c:pt>
                <c:pt idx="34">
                  <c:v>787878</c:v>
                </c:pt>
                <c:pt idx="35">
                  <c:v>721277</c:v>
                </c:pt>
                <c:pt idx="36">
                  <c:v>782965</c:v>
                </c:pt>
                <c:pt idx="37">
                  <c:v>615262</c:v>
                </c:pt>
                <c:pt idx="38">
                  <c:v>774579</c:v>
                </c:pt>
                <c:pt idx="39">
                  <c:v>731411</c:v>
                </c:pt>
                <c:pt idx="40">
                  <c:v>747670</c:v>
                </c:pt>
                <c:pt idx="41">
                  <c:v>728636</c:v>
                </c:pt>
                <c:pt idx="42">
                  <c:v>792012</c:v>
                </c:pt>
                <c:pt idx="43">
                  <c:v>734938</c:v>
                </c:pt>
                <c:pt idx="44">
                  <c:v>727095</c:v>
                </c:pt>
                <c:pt idx="45">
                  <c:v>742344</c:v>
                </c:pt>
                <c:pt idx="46">
                  <c:v>756294</c:v>
                </c:pt>
                <c:pt idx="47">
                  <c:v>712462</c:v>
                </c:pt>
                <c:pt idx="48">
                  <c:v>749824</c:v>
                </c:pt>
                <c:pt idx="49">
                  <c:v>497134</c:v>
                </c:pt>
                <c:pt idx="50">
                  <c:v>729271</c:v>
                </c:pt>
                <c:pt idx="51">
                  <c:v>760910</c:v>
                </c:pt>
                <c:pt idx="52">
                  <c:v>692489</c:v>
                </c:pt>
                <c:pt idx="53">
                  <c:v>680289</c:v>
                </c:pt>
                <c:pt idx="54">
                  <c:v>703889</c:v>
                </c:pt>
                <c:pt idx="55">
                  <c:v>648728</c:v>
                </c:pt>
                <c:pt idx="56">
                  <c:v>676734</c:v>
                </c:pt>
                <c:pt idx="57">
                  <c:v>710753</c:v>
                </c:pt>
                <c:pt idx="58">
                  <c:v>704642</c:v>
                </c:pt>
                <c:pt idx="59">
                  <c:v>698166</c:v>
                </c:pt>
                <c:pt idx="60">
                  <c:v>675034</c:v>
                </c:pt>
                <c:pt idx="61">
                  <c:v>641148</c:v>
                </c:pt>
                <c:pt idx="62">
                  <c:v>734125</c:v>
                </c:pt>
                <c:pt idx="63">
                  <c:v>744745</c:v>
                </c:pt>
                <c:pt idx="64">
                  <c:v>714479</c:v>
                </c:pt>
                <c:pt idx="65">
                  <c:v>703710</c:v>
                </c:pt>
                <c:pt idx="66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1097344"/>
        <c:axId val="131098880"/>
      </c:barChart>
      <c:catAx>
        <c:axId val="13109734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bg1">
                <a:lumMod val="85000"/>
              </a:schemeClr>
            </a:solidFill>
          </a:ln>
        </c:spPr>
        <c:txPr>
          <a:bodyPr/>
          <a:lstStyle/>
          <a:p>
            <a:pPr>
              <a:defRPr>
                <a:latin typeface="Arial Narrow" pitchFamily="34" charset="0"/>
              </a:defRPr>
            </a:pPr>
            <a:endParaRPr lang="ja-JP"/>
          </a:p>
        </c:txPr>
        <c:crossAx val="131098880"/>
        <c:crosses val="autoZero"/>
        <c:auto val="1"/>
        <c:lblAlgn val="ctr"/>
        <c:lblOffset val="100"/>
        <c:noMultiLvlLbl val="0"/>
      </c:catAx>
      <c:valAx>
        <c:axId val="131098880"/>
        <c:scaling>
          <c:orientation val="minMax"/>
        </c:scaling>
        <c:delete val="0"/>
        <c:axPos val="l"/>
        <c:numFmt formatCode="#,##0_);[Red]\(#,##0\)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 Narrow" pitchFamily="34" charset="0"/>
              </a:defRPr>
            </a:pPr>
            <a:endParaRPr lang="ja-JP"/>
          </a:p>
        </c:txPr>
        <c:crossAx val="131097344"/>
        <c:crosses val="autoZero"/>
        <c:crossBetween val="between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117048288942893E-2"/>
          <c:y val="6.1747357394323396E-2"/>
          <c:w val="0.88295547812487296"/>
          <c:h val="0.6821792352963276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ppl. Table 1'!$J$2</c:f>
              <c:strCache>
                <c:ptCount val="1"/>
                <c:pt idx="0">
                  <c:v>No. of returnee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accent4">
                  <a:lumMod val="50000"/>
                </a:schemeClr>
              </a:solidFill>
            </a:ln>
          </c:spPr>
          <c:invertIfNegative val="0"/>
          <c:cat>
            <c:multiLvlStrRef>
              <c:f>'Suppl. Table 1'!$H$3:$I$74</c:f>
              <c:multiLvlStrCache>
                <c:ptCount val="72"/>
                <c:lvl>
                  <c:pt idx="0">
                    <c:v>Jan.</c:v>
                  </c:pt>
                  <c:pt idx="1">
                    <c:v>Feb.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  <c:pt idx="24">
                    <c:v>Jan</c:v>
                  </c:pt>
                  <c:pt idx="25">
                    <c:v>Feb</c:v>
                  </c:pt>
                  <c:pt idx="26">
                    <c:v>Mar</c:v>
                  </c:pt>
                  <c:pt idx="27">
                    <c:v>Apr</c:v>
                  </c:pt>
                  <c:pt idx="28">
                    <c:v>May</c:v>
                  </c:pt>
                  <c:pt idx="29">
                    <c:v>Jun</c:v>
                  </c:pt>
                  <c:pt idx="30">
                    <c:v>Jul</c:v>
                  </c:pt>
                  <c:pt idx="31">
                    <c:v>Aug</c:v>
                  </c:pt>
                  <c:pt idx="32">
                    <c:v>Sep</c:v>
                  </c:pt>
                  <c:pt idx="33">
                    <c:v>Oct</c:v>
                  </c:pt>
                  <c:pt idx="34">
                    <c:v>Nov</c:v>
                  </c:pt>
                  <c:pt idx="35">
                    <c:v>Dec</c:v>
                  </c:pt>
                  <c:pt idx="36">
                    <c:v>Jan</c:v>
                  </c:pt>
                  <c:pt idx="37">
                    <c:v>Feb</c:v>
                  </c:pt>
                  <c:pt idx="38">
                    <c:v>Mar</c:v>
                  </c:pt>
                  <c:pt idx="39">
                    <c:v>Apr</c:v>
                  </c:pt>
                  <c:pt idx="40">
                    <c:v>May</c:v>
                  </c:pt>
                  <c:pt idx="41">
                    <c:v>Jun</c:v>
                  </c:pt>
                  <c:pt idx="42">
                    <c:v>Jul</c:v>
                  </c:pt>
                  <c:pt idx="43">
                    <c:v>Aug</c:v>
                  </c:pt>
                  <c:pt idx="44">
                    <c:v>Sep</c:v>
                  </c:pt>
                  <c:pt idx="45">
                    <c:v>Oct</c:v>
                  </c:pt>
                  <c:pt idx="46">
                    <c:v>Nov</c:v>
                  </c:pt>
                  <c:pt idx="47">
                    <c:v>Dec</c:v>
                  </c:pt>
                  <c:pt idx="48">
                    <c:v>Jan</c:v>
                  </c:pt>
                  <c:pt idx="49">
                    <c:v>Feb</c:v>
                  </c:pt>
                  <c:pt idx="50">
                    <c:v>Mar</c:v>
                  </c:pt>
                  <c:pt idx="51">
                    <c:v>Apr</c:v>
                  </c:pt>
                  <c:pt idx="52">
                    <c:v>May</c:v>
                  </c:pt>
                  <c:pt idx="53">
                    <c:v>Jun</c:v>
                  </c:pt>
                  <c:pt idx="54">
                    <c:v>Jul</c:v>
                  </c:pt>
                  <c:pt idx="55">
                    <c:v>Aug</c:v>
                  </c:pt>
                  <c:pt idx="56">
                    <c:v>Sep</c:v>
                  </c:pt>
                  <c:pt idx="57">
                    <c:v>Oct</c:v>
                  </c:pt>
                  <c:pt idx="58">
                    <c:v>Nov</c:v>
                  </c:pt>
                  <c:pt idx="59">
                    <c:v>Dec</c:v>
                  </c:pt>
                  <c:pt idx="60">
                    <c:v>Jan</c:v>
                  </c:pt>
                  <c:pt idx="61">
                    <c:v>Feb</c:v>
                  </c:pt>
                  <c:pt idx="62">
                    <c:v>Mar</c:v>
                  </c:pt>
                  <c:pt idx="63">
                    <c:v>Apr</c:v>
                  </c:pt>
                  <c:pt idx="64">
                    <c:v>May</c:v>
                  </c:pt>
                  <c:pt idx="65">
                    <c:v>Jun</c:v>
                  </c:pt>
                  <c:pt idx="66">
                    <c:v>Jul</c:v>
                  </c:pt>
                  <c:pt idx="67">
                    <c:v>Aug</c:v>
                  </c:pt>
                  <c:pt idx="68">
                    <c:v>Sep</c:v>
                  </c:pt>
                  <c:pt idx="69">
                    <c:v>Oct</c:v>
                  </c:pt>
                  <c:pt idx="70">
                    <c:v>Nov</c:v>
                  </c:pt>
                  <c:pt idx="71">
                    <c:v>Dec</c:v>
                  </c:pt>
                </c:lvl>
                <c:lvl>
                  <c:pt idx="0">
                    <c:v>2016</c:v>
                  </c:pt>
                  <c:pt idx="12">
                    <c:v>2017</c:v>
                  </c:pt>
                  <c:pt idx="24">
                    <c:v>2018</c:v>
                  </c:pt>
                  <c:pt idx="36">
                    <c:v>2019</c:v>
                  </c:pt>
                  <c:pt idx="48">
                    <c:v>2020</c:v>
                  </c:pt>
                  <c:pt idx="60">
                    <c:v>2021</c:v>
                  </c:pt>
                </c:lvl>
              </c:multiLvlStrCache>
            </c:multiLvlStrRef>
          </c:cat>
          <c:val>
            <c:numRef>
              <c:f>'Suppl. Table 1'!$J$3:$J$74</c:f>
              <c:numCache>
                <c:formatCode>#,##0</c:formatCode>
                <c:ptCount val="72"/>
                <c:pt idx="0">
                  <c:v>1327934</c:v>
                </c:pt>
                <c:pt idx="1">
                  <c:v>1249714</c:v>
                </c:pt>
                <c:pt idx="2">
                  <c:v>1666757</c:v>
                </c:pt>
                <c:pt idx="3">
                  <c:v>1112783</c:v>
                </c:pt>
                <c:pt idx="4">
                  <c:v>1355176</c:v>
                </c:pt>
                <c:pt idx="5">
                  <c:v>1294226</c:v>
                </c:pt>
                <c:pt idx="6">
                  <c:v>1374293</c:v>
                </c:pt>
                <c:pt idx="7" formatCode="General">
                  <c:v>1774634</c:v>
                </c:pt>
                <c:pt idx="8" formatCode="General">
                  <c:v>1604107</c:v>
                </c:pt>
                <c:pt idx="9" formatCode="General">
                  <c:v>1456787</c:v>
                </c:pt>
                <c:pt idx="10">
                  <c:v>1468345</c:v>
                </c:pt>
                <c:pt idx="11">
                  <c:v>1403496</c:v>
                </c:pt>
                <c:pt idx="12" formatCode="General">
                  <c:v>1436386</c:v>
                </c:pt>
                <c:pt idx="13">
                  <c:v>1331819</c:v>
                </c:pt>
                <c:pt idx="14" formatCode="General">
                  <c:v>1843939</c:v>
                </c:pt>
                <c:pt idx="15" formatCode="General">
                  <c:v>1183666</c:v>
                </c:pt>
                <c:pt idx="16">
                  <c:v>1388836</c:v>
                </c:pt>
                <c:pt idx="17">
                  <c:v>1360735</c:v>
                </c:pt>
                <c:pt idx="18">
                  <c:v>1422671</c:v>
                </c:pt>
                <c:pt idx="19" formatCode="General">
                  <c:v>1833092</c:v>
                </c:pt>
                <c:pt idx="20">
                  <c:v>1704807</c:v>
                </c:pt>
                <c:pt idx="21" formatCode="General">
                  <c:v>1410813</c:v>
                </c:pt>
                <c:pt idx="22">
                  <c:v>1549609</c:v>
                </c:pt>
                <c:pt idx="23" formatCode="General">
                  <c:v>1410080</c:v>
                </c:pt>
                <c:pt idx="24">
                  <c:v>1479500</c:v>
                </c:pt>
                <c:pt idx="25" formatCode="General">
                  <c:v>1325270</c:v>
                </c:pt>
                <c:pt idx="26">
                  <c:v>1912124</c:v>
                </c:pt>
                <c:pt idx="27">
                  <c:v>1252052</c:v>
                </c:pt>
                <c:pt idx="28">
                  <c:v>1481754</c:v>
                </c:pt>
                <c:pt idx="29">
                  <c:v>1448600</c:v>
                </c:pt>
                <c:pt idx="30">
                  <c:v>1504890</c:v>
                </c:pt>
                <c:pt idx="31" formatCode="General">
                  <c:v>1964601</c:v>
                </c:pt>
                <c:pt idx="32">
                  <c:v>1719802</c:v>
                </c:pt>
                <c:pt idx="33" formatCode="General">
                  <c:v>1601792</c:v>
                </c:pt>
                <c:pt idx="34">
                  <c:v>1675859</c:v>
                </c:pt>
                <c:pt idx="35">
                  <c:v>1542710</c:v>
                </c:pt>
                <c:pt idx="36">
                  <c:v>1567008</c:v>
                </c:pt>
                <c:pt idx="37">
                  <c:v>1389824</c:v>
                </c:pt>
                <c:pt idx="38">
                  <c:v>2054155</c:v>
                </c:pt>
                <c:pt idx="39">
                  <c:v>1269871</c:v>
                </c:pt>
                <c:pt idx="40">
                  <c:v>1838301</c:v>
                </c:pt>
                <c:pt idx="41">
                  <c:v>1547666</c:v>
                </c:pt>
                <c:pt idx="42">
                  <c:v>1589288</c:v>
                </c:pt>
                <c:pt idx="43" formatCode="General">
                  <c:v>2061962</c:v>
                </c:pt>
                <c:pt idx="44" formatCode="General">
                  <c:v>1850064</c:v>
                </c:pt>
                <c:pt idx="45" formatCode="General">
                  <c:v>1585490</c:v>
                </c:pt>
                <c:pt idx="46" formatCode="General">
                  <c:v>1674511</c:v>
                </c:pt>
                <c:pt idx="47">
                  <c:v>1601915</c:v>
                </c:pt>
                <c:pt idx="48" formatCode="General">
                  <c:v>1608306</c:v>
                </c:pt>
                <c:pt idx="49" formatCode="General">
                  <c:v>1289648</c:v>
                </c:pt>
                <c:pt idx="50" formatCode="General">
                  <c:v>521730</c:v>
                </c:pt>
                <c:pt idx="51" formatCode="General">
                  <c:v>38983</c:v>
                </c:pt>
                <c:pt idx="52" formatCode="General">
                  <c:v>14864</c:v>
                </c:pt>
                <c:pt idx="53" formatCode="General">
                  <c:v>20615</c:v>
                </c:pt>
                <c:pt idx="54" formatCode="General">
                  <c:v>27135</c:v>
                </c:pt>
                <c:pt idx="55" formatCode="General">
                  <c:v>23939</c:v>
                </c:pt>
                <c:pt idx="56" formatCode="General">
                  <c:v>23351</c:v>
                </c:pt>
                <c:pt idx="57" formatCode="General">
                  <c:v>26645</c:v>
                </c:pt>
                <c:pt idx="58" formatCode="General">
                  <c:v>30453</c:v>
                </c:pt>
                <c:pt idx="59" formatCode="General">
                  <c:v>57601</c:v>
                </c:pt>
                <c:pt idx="60" formatCode="General">
                  <c:v>25232</c:v>
                </c:pt>
                <c:pt idx="61" formatCode="General">
                  <c:v>20994</c:v>
                </c:pt>
                <c:pt idx="62" formatCode="General">
                  <c:v>38929</c:v>
                </c:pt>
                <c:pt idx="63" formatCode="General">
                  <c:v>29795</c:v>
                </c:pt>
                <c:pt idx="64" formatCode="0_);[Red]\(0\)">
                  <c:v>32414</c:v>
                </c:pt>
                <c:pt idx="65" formatCode="0_);[Red]\(0\)">
                  <c:v>43441</c:v>
                </c:pt>
                <c:pt idx="66" formatCode="0_);[Red]\(0\)">
                  <c:v>51628</c:v>
                </c:pt>
                <c:pt idx="67" formatCode="0_);[Red]\(0\)">
                  <c:v>45555</c:v>
                </c:pt>
                <c:pt idx="68" formatCode="0_);[Red]\(0\)">
                  <c:v>52366</c:v>
                </c:pt>
                <c:pt idx="69" formatCode="0_);[Red]\(0\)">
                  <c:v>42209</c:v>
                </c:pt>
                <c:pt idx="70" formatCode="0_);[Red]\(0\)">
                  <c:v>48098</c:v>
                </c:pt>
                <c:pt idx="71" formatCode="0_);[Red]\(0\)">
                  <c:v>845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1233280"/>
        <c:axId val="131234816"/>
      </c:barChart>
      <c:catAx>
        <c:axId val="13123328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bg1">
                <a:lumMod val="85000"/>
              </a:schemeClr>
            </a:solidFill>
          </a:ln>
        </c:spPr>
        <c:txPr>
          <a:bodyPr/>
          <a:lstStyle/>
          <a:p>
            <a:pPr>
              <a:defRPr>
                <a:latin typeface="Arial Narrow" pitchFamily="34" charset="0"/>
              </a:defRPr>
            </a:pPr>
            <a:endParaRPr lang="ja-JP"/>
          </a:p>
        </c:txPr>
        <c:crossAx val="131234816"/>
        <c:crosses val="autoZero"/>
        <c:auto val="1"/>
        <c:lblAlgn val="ctr"/>
        <c:lblOffset val="100"/>
        <c:noMultiLvlLbl val="0"/>
      </c:catAx>
      <c:valAx>
        <c:axId val="131234816"/>
        <c:scaling>
          <c:orientation val="minMax"/>
        </c:scaling>
        <c:delete val="0"/>
        <c:axPos val="l"/>
        <c:numFmt formatCode="#,##0" sourceLinked="1"/>
        <c:majorTickMark val="out"/>
        <c:minorTickMark val="none"/>
        <c:tickLblPos val="nextTo"/>
        <c:spPr>
          <a:ln>
            <a:solidFill>
              <a:schemeClr val="bg1">
                <a:lumMod val="65000"/>
              </a:schemeClr>
            </a:solidFill>
          </a:ln>
        </c:spPr>
        <c:txPr>
          <a:bodyPr/>
          <a:lstStyle/>
          <a:p>
            <a:pPr>
              <a:defRPr>
                <a:latin typeface="Arial Narrow" pitchFamily="34" charset="0"/>
              </a:defRPr>
            </a:pPr>
            <a:endParaRPr lang="ja-JP"/>
          </a:p>
        </c:txPr>
        <c:crossAx val="131233280"/>
        <c:crosses val="autoZero"/>
        <c:crossBetween val="between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446648299079577"/>
          <c:y val="6.7684636493530792E-2"/>
          <c:w val="0.80086165216190086"/>
          <c:h val="0.70924971846921869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[Microsoft PowerPoint 内のグラフ]Sheet1'!$A$26</c:f>
              <c:strCache>
                <c:ptCount val="1"/>
                <c:pt idx="0">
                  <c:v>Asian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multiLvlStrRef>
              <c:f>'[Microsoft PowerPoint 内のグラフ]Sheet1'!$C$24:$W$25</c:f>
              <c:multiLvlStrCache>
                <c:ptCount val="21"/>
                <c:lvl>
                  <c:pt idx="0">
                    <c:v>Apr.</c:v>
                  </c:pt>
                  <c:pt idx="1">
                    <c:v>May.</c:v>
                  </c:pt>
                  <c:pt idx="2">
                    <c:v>June</c:v>
                  </c:pt>
                  <c:pt idx="3">
                    <c:v>July.</c:v>
                  </c:pt>
                  <c:pt idx="4">
                    <c:v>Aug.</c:v>
                  </c:pt>
                  <c:pt idx="5">
                    <c:v>Sep.</c:v>
                  </c:pt>
                  <c:pt idx="6">
                    <c:v>Oct.</c:v>
                  </c:pt>
                  <c:pt idx="7">
                    <c:v>Nov.</c:v>
                  </c:pt>
                  <c:pt idx="8">
                    <c:v>Dec.</c:v>
                  </c:pt>
                  <c:pt idx="9">
                    <c:v>Jan.</c:v>
                  </c:pt>
                  <c:pt idx="10">
                    <c:v>Feb.</c:v>
                  </c:pt>
                  <c:pt idx="11">
                    <c:v>Mar.</c:v>
                  </c:pt>
                  <c:pt idx="12">
                    <c:v>Apr.</c:v>
                  </c:pt>
                  <c:pt idx="13">
                    <c:v>May.</c:v>
                  </c:pt>
                  <c:pt idx="14">
                    <c:v>June</c:v>
                  </c:pt>
                  <c:pt idx="15">
                    <c:v>July.</c:v>
                  </c:pt>
                  <c:pt idx="16">
                    <c:v>Aug.</c:v>
                  </c:pt>
                  <c:pt idx="17">
                    <c:v>Sep.</c:v>
                  </c:pt>
                  <c:pt idx="18">
                    <c:v>Oct.</c:v>
                  </c:pt>
                  <c:pt idx="19">
                    <c:v>Nov.</c:v>
                  </c:pt>
                  <c:pt idx="20">
                    <c:v>Dec.</c:v>
                  </c:pt>
                </c:lvl>
                <c:lvl>
                  <c:pt idx="9">
                    <c:v>2021</c:v>
                  </c:pt>
                </c:lvl>
              </c:multiLvlStrCache>
            </c:multiLvlStrRef>
          </c:cat>
          <c:val>
            <c:numRef>
              <c:f>'[Microsoft PowerPoint 内のグラフ]Sheet1'!$C$26:$W$26</c:f>
              <c:numCache>
                <c:formatCode>General</c:formatCode>
                <c:ptCount val="21"/>
                <c:pt idx="0">
                  <c:v>4034</c:v>
                </c:pt>
                <c:pt idx="1">
                  <c:v>3766</c:v>
                </c:pt>
                <c:pt idx="2">
                  <c:v>6754</c:v>
                </c:pt>
                <c:pt idx="3">
                  <c:v>8241</c:v>
                </c:pt>
                <c:pt idx="4">
                  <c:v>11868</c:v>
                </c:pt>
                <c:pt idx="5">
                  <c:v>15724</c:v>
                </c:pt>
                <c:pt idx="6">
                  <c:v>29220</c:v>
                </c:pt>
                <c:pt idx="7">
                  <c:v>58669</c:v>
                </c:pt>
                <c:pt idx="8">
                  <c:v>61868</c:v>
                </c:pt>
                <c:pt idx="9">
                  <c:v>48317</c:v>
                </c:pt>
                <c:pt idx="10">
                  <c:v>10870</c:v>
                </c:pt>
                <c:pt idx="11">
                  <c:v>15565</c:v>
                </c:pt>
                <c:pt idx="12">
                  <c:v>13303</c:v>
                </c:pt>
                <c:pt idx="13">
                  <c:v>12163</c:v>
                </c:pt>
                <c:pt idx="14">
                  <c:v>11245</c:v>
                </c:pt>
                <c:pt idx="15">
                  <c:v>16777</c:v>
                </c:pt>
                <c:pt idx="16">
                  <c:v>14123</c:v>
                </c:pt>
                <c:pt idx="17">
                  <c:v>18634</c:v>
                </c:pt>
                <c:pt idx="18">
                  <c:v>22712</c:v>
                </c:pt>
                <c:pt idx="19">
                  <c:v>23611</c:v>
                </c:pt>
                <c:pt idx="20">
                  <c:v>17612</c:v>
                </c:pt>
              </c:numCache>
            </c:numRef>
          </c:val>
        </c:ser>
        <c:ser>
          <c:idx val="1"/>
          <c:order val="1"/>
          <c:tx>
            <c:strRef>
              <c:f>'[Microsoft PowerPoint 内のグラフ]Sheet1'!$A$27</c:f>
              <c:strCache>
                <c:ptCount val="1"/>
                <c:pt idx="0">
                  <c:v>Non-Asian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multiLvlStrRef>
              <c:f>'[Microsoft PowerPoint 内のグラフ]Sheet1'!$C$24:$W$25</c:f>
              <c:multiLvlStrCache>
                <c:ptCount val="21"/>
                <c:lvl>
                  <c:pt idx="0">
                    <c:v>Apr.</c:v>
                  </c:pt>
                  <c:pt idx="1">
                    <c:v>May.</c:v>
                  </c:pt>
                  <c:pt idx="2">
                    <c:v>June</c:v>
                  </c:pt>
                  <c:pt idx="3">
                    <c:v>July.</c:v>
                  </c:pt>
                  <c:pt idx="4">
                    <c:v>Aug.</c:v>
                  </c:pt>
                  <c:pt idx="5">
                    <c:v>Sep.</c:v>
                  </c:pt>
                  <c:pt idx="6">
                    <c:v>Oct.</c:v>
                  </c:pt>
                  <c:pt idx="7">
                    <c:v>Nov.</c:v>
                  </c:pt>
                  <c:pt idx="8">
                    <c:v>Dec.</c:v>
                  </c:pt>
                  <c:pt idx="9">
                    <c:v>Jan.</c:v>
                  </c:pt>
                  <c:pt idx="10">
                    <c:v>Feb.</c:v>
                  </c:pt>
                  <c:pt idx="11">
                    <c:v>Mar.</c:v>
                  </c:pt>
                  <c:pt idx="12">
                    <c:v>Apr.</c:v>
                  </c:pt>
                  <c:pt idx="13">
                    <c:v>May.</c:v>
                  </c:pt>
                  <c:pt idx="14">
                    <c:v>June</c:v>
                  </c:pt>
                  <c:pt idx="15">
                    <c:v>July.</c:v>
                  </c:pt>
                  <c:pt idx="16">
                    <c:v>Aug.</c:v>
                  </c:pt>
                  <c:pt idx="17">
                    <c:v>Sep.</c:v>
                  </c:pt>
                  <c:pt idx="18">
                    <c:v>Oct.</c:v>
                  </c:pt>
                  <c:pt idx="19">
                    <c:v>Nov.</c:v>
                  </c:pt>
                  <c:pt idx="20">
                    <c:v>Dec.</c:v>
                  </c:pt>
                </c:lvl>
                <c:lvl>
                  <c:pt idx="9">
                    <c:v>2021</c:v>
                  </c:pt>
                </c:lvl>
              </c:multiLvlStrCache>
            </c:multiLvlStrRef>
          </c:cat>
          <c:val>
            <c:numRef>
              <c:f>'[Microsoft PowerPoint 内のグラフ]Sheet1'!$C$27:$W$27</c:f>
              <c:numCache>
                <c:formatCode>General</c:formatCode>
                <c:ptCount val="21"/>
                <c:pt idx="0">
                  <c:v>1278</c:v>
                </c:pt>
                <c:pt idx="1">
                  <c:v>722</c:v>
                </c:pt>
                <c:pt idx="2">
                  <c:v>1274</c:v>
                </c:pt>
                <c:pt idx="3">
                  <c:v>2059</c:v>
                </c:pt>
                <c:pt idx="4">
                  <c:v>4014</c:v>
                </c:pt>
                <c:pt idx="5">
                  <c:v>3137</c:v>
                </c:pt>
                <c:pt idx="6">
                  <c:v>6358</c:v>
                </c:pt>
                <c:pt idx="7">
                  <c:v>7934</c:v>
                </c:pt>
                <c:pt idx="8">
                  <c:v>7874</c:v>
                </c:pt>
                <c:pt idx="9">
                  <c:v>7401</c:v>
                </c:pt>
                <c:pt idx="10">
                  <c:v>2962</c:v>
                </c:pt>
                <c:pt idx="11">
                  <c:v>3833</c:v>
                </c:pt>
                <c:pt idx="12">
                  <c:v>4255</c:v>
                </c:pt>
                <c:pt idx="13">
                  <c:v>5213</c:v>
                </c:pt>
                <c:pt idx="14">
                  <c:v>6040</c:v>
                </c:pt>
                <c:pt idx="15">
                  <c:v>42688</c:v>
                </c:pt>
                <c:pt idx="16">
                  <c:v>20842</c:v>
                </c:pt>
                <c:pt idx="17">
                  <c:v>9122</c:v>
                </c:pt>
                <c:pt idx="18">
                  <c:v>10516</c:v>
                </c:pt>
                <c:pt idx="19">
                  <c:v>9140</c:v>
                </c:pt>
                <c:pt idx="20">
                  <c:v>61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serLines/>
        <c:axId val="131384448"/>
        <c:axId val="131385984"/>
      </c:barChart>
      <c:catAx>
        <c:axId val="1313844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 Narrow" pitchFamily="34" charset="0"/>
              </a:defRPr>
            </a:pPr>
            <a:endParaRPr lang="ja-JP"/>
          </a:p>
        </c:txPr>
        <c:crossAx val="131385984"/>
        <c:crosses val="autoZero"/>
        <c:auto val="1"/>
        <c:lblAlgn val="ctr"/>
        <c:lblOffset val="100"/>
        <c:noMultiLvlLbl val="1"/>
      </c:catAx>
      <c:valAx>
        <c:axId val="1313859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 Narrow" pitchFamily="34" charset="0"/>
              </a:defRPr>
            </a:pPr>
            <a:endParaRPr lang="ja-JP"/>
          </a:p>
        </c:txPr>
        <c:crossAx val="131384448"/>
        <c:crosses val="autoZero"/>
        <c:crossBetween val="between"/>
      </c:valAx>
      <c:spPr>
        <a:solidFill>
          <a:schemeClr val="bg1">
            <a:lumMod val="95000"/>
          </a:schemeClr>
        </a:solidFill>
      </c:spPr>
    </c:plotArea>
    <c:legend>
      <c:legendPos val="r"/>
      <c:layout>
        <c:manualLayout>
          <c:xMode val="edge"/>
          <c:yMode val="edge"/>
          <c:x val="0.65218228611073881"/>
          <c:y val="6.5368969205622199E-2"/>
          <c:w val="0.30374874562157705"/>
          <c:h val="0.16356552006050049"/>
        </c:manualLayout>
      </c:layout>
      <c:overlay val="1"/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397398-78E9-4292-A63B-134A0E1562A0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6125"/>
            <a:ext cx="27940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5125" cy="4471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9FB13B-18E4-4199-A5A6-D030235CC6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1358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0631130-727B-4B33-B16F-55DE450F3B17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272108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093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1865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2698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782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9538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073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5112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28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4200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586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63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4615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5471884"/>
              </p:ext>
            </p:extLst>
          </p:nvPr>
        </p:nvGraphicFramePr>
        <p:xfrm>
          <a:off x="274240" y="1945158"/>
          <a:ext cx="6476965" cy="2401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6" name="テキスト ボックス 15"/>
          <p:cNvSpPr txBox="1"/>
          <p:nvPr/>
        </p:nvSpPr>
        <p:spPr>
          <a:xfrm>
            <a:off x="3356992" y="4223574"/>
            <a:ext cx="8643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000" dirty="0" smtClean="0">
                <a:latin typeface="Arial Narrow" pitchFamily="34" charset="0"/>
              </a:rPr>
              <a:t>（</a:t>
            </a:r>
            <a:r>
              <a:rPr lang="en-US" altLang="ja-JP" sz="1000" dirty="0" smtClean="0">
                <a:latin typeface="Arial Narrow" pitchFamily="34" charset="0"/>
              </a:rPr>
              <a:t>month / year)</a:t>
            </a:r>
            <a:endParaRPr kumimoji="1" lang="ja-JP" altLang="en-US" sz="1000" dirty="0">
              <a:latin typeface="Arial Narrow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 rot="16200000">
            <a:off x="-37605" y="2401539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000" dirty="0" smtClean="0">
                <a:latin typeface="Arial Narrow" pitchFamily="34" charset="0"/>
              </a:rPr>
              <a:t>（</a:t>
            </a:r>
            <a:r>
              <a:rPr lang="en-US" altLang="ja-JP" sz="1000" dirty="0" smtClean="0">
                <a:latin typeface="Arial Narrow" pitchFamily="34" charset="0"/>
              </a:rPr>
              <a:t>number)</a:t>
            </a:r>
            <a:endParaRPr kumimoji="1" lang="ja-JP" altLang="en-US" sz="1000" dirty="0">
              <a:latin typeface="Arial Narrow" pitchFamily="34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6156078" y="8781088"/>
            <a:ext cx="59182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3 Fig.</a:t>
            </a:r>
            <a:endParaRPr lang="ja-JP" altLang="en-US" dirty="0"/>
          </a:p>
        </p:txBody>
      </p:sp>
      <p:graphicFrame>
        <p:nvGraphicFramePr>
          <p:cNvPr id="23" name="グラフ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4676039"/>
              </p:ext>
            </p:extLst>
          </p:nvPr>
        </p:nvGraphicFramePr>
        <p:xfrm>
          <a:off x="476672" y="6774051"/>
          <a:ext cx="6274533" cy="19953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6" name="テキスト ボックス 25"/>
          <p:cNvSpPr txBox="1"/>
          <p:nvPr/>
        </p:nvSpPr>
        <p:spPr>
          <a:xfrm>
            <a:off x="3356992" y="6486019"/>
            <a:ext cx="8643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000" dirty="0" smtClean="0">
                <a:latin typeface="Arial Narrow" pitchFamily="34" charset="0"/>
              </a:rPr>
              <a:t>（</a:t>
            </a:r>
            <a:r>
              <a:rPr lang="en-US" altLang="ja-JP" sz="1000" dirty="0" smtClean="0">
                <a:latin typeface="Arial Narrow" pitchFamily="34" charset="0"/>
              </a:rPr>
              <a:t>month / year)</a:t>
            </a:r>
            <a:endParaRPr kumimoji="1" lang="ja-JP" altLang="en-US" sz="1000" dirty="0">
              <a:latin typeface="Arial Narrow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428757" y="8646259"/>
            <a:ext cx="8643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000" dirty="0" smtClean="0">
                <a:latin typeface="Arial Narrow" pitchFamily="34" charset="0"/>
              </a:rPr>
              <a:t>（</a:t>
            </a:r>
            <a:r>
              <a:rPr lang="en-US" altLang="ja-JP" sz="1000" dirty="0" smtClean="0">
                <a:latin typeface="Arial Narrow" pitchFamily="34" charset="0"/>
              </a:rPr>
              <a:t>month / year)</a:t>
            </a:r>
            <a:endParaRPr kumimoji="1" lang="ja-JP" altLang="en-US" sz="1000" dirty="0">
              <a:latin typeface="Arial Narrow" pitchFamily="34" charset="0"/>
            </a:endParaRPr>
          </a:p>
        </p:txBody>
      </p:sp>
      <p:graphicFrame>
        <p:nvGraphicFramePr>
          <p:cNvPr id="28" name="グラフ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4471097"/>
              </p:ext>
            </p:extLst>
          </p:nvPr>
        </p:nvGraphicFramePr>
        <p:xfrm>
          <a:off x="380202" y="4346684"/>
          <a:ext cx="6371003" cy="22624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" name="左中かっこ 3"/>
          <p:cNvSpPr/>
          <p:nvPr/>
        </p:nvSpPr>
        <p:spPr>
          <a:xfrm rot="5400000">
            <a:off x="5553236" y="2345559"/>
            <a:ext cx="360040" cy="1584176"/>
          </a:xfrm>
          <a:prstGeom prst="lef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下矢印 4"/>
          <p:cNvSpPr/>
          <p:nvPr/>
        </p:nvSpPr>
        <p:spPr>
          <a:xfrm rot="10800000">
            <a:off x="5481228" y="2309555"/>
            <a:ext cx="396044" cy="441098"/>
          </a:xfrm>
          <a:prstGeom prst="downArrow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テキスト ボックス 29"/>
          <p:cNvSpPr txBox="1"/>
          <p:nvPr/>
        </p:nvSpPr>
        <p:spPr>
          <a:xfrm rot="16200000">
            <a:off x="-23178" y="4881871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 Narrow" pitchFamily="34" charset="0"/>
              </a:rPr>
              <a:t>(number)</a:t>
            </a:r>
            <a:endParaRPr kumimoji="1" lang="ja-JP" altLang="en-US" sz="1000" dirty="0">
              <a:latin typeface="Arial Narrow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 rot="16200000">
            <a:off x="-23178" y="7201893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 Narrow" pitchFamily="34" charset="0"/>
              </a:rPr>
              <a:t>(number)</a:t>
            </a:r>
            <a:endParaRPr kumimoji="1" lang="ja-JP" altLang="en-US" sz="1000" dirty="0">
              <a:latin typeface="Arial Narrow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974962" y="2073786"/>
            <a:ext cx="1178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(a) Foreign arrival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974962" y="4511025"/>
            <a:ext cx="16241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(b) Returnees</a:t>
            </a:r>
            <a:r>
              <a:rPr lang="ja-JP" altLang="en-US" sz="1200" dirty="0">
                <a:latin typeface="Arial Narrow" pitchFamily="34" charset="0"/>
              </a:rPr>
              <a:t> </a:t>
            </a:r>
            <a:r>
              <a:rPr lang="en-US" altLang="ja-JP" sz="1200" dirty="0" smtClean="0">
                <a:latin typeface="Arial Narrow" pitchFamily="34" charset="0"/>
              </a:rPr>
              <a:t>(Japanese)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974962" y="6876256"/>
            <a:ext cx="1495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(c) Containerized cargo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797152" y="1831921"/>
            <a:ext cx="12747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 Narrow" pitchFamily="34" charset="0"/>
              </a:rPr>
              <a:t>2020                  2021</a:t>
            </a:r>
            <a:endParaRPr kumimoji="1" lang="ja-JP" altLang="en-US" sz="1100" dirty="0">
              <a:latin typeface="Arial Narrow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4579002" y="437934"/>
            <a:ext cx="3946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>
                <a:latin typeface="Arial Narrow" pitchFamily="34" charset="0"/>
              </a:rPr>
              <a:t>(a’)</a:t>
            </a:r>
            <a:endParaRPr kumimoji="1" lang="ja-JP" altLang="en-US" sz="1400" dirty="0">
              <a:latin typeface="Arial Narrow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6165312" y="1908785"/>
            <a:ext cx="108000" cy="45719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/>
          <p:cNvSpPr/>
          <p:nvPr/>
        </p:nvSpPr>
        <p:spPr>
          <a:xfrm>
            <a:off x="6309328" y="1907704"/>
            <a:ext cx="72000" cy="46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25" name="グラフ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5689984"/>
              </p:ext>
            </p:extLst>
          </p:nvPr>
        </p:nvGraphicFramePr>
        <p:xfrm>
          <a:off x="4042880" y="231198"/>
          <a:ext cx="2783251" cy="1669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42928205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22</TotalTime>
  <Words>50</Words>
  <Application>Microsoft Office PowerPoint</Application>
  <PresentationFormat>画面に合わせる (4:3)</PresentationFormat>
  <Paragraphs>13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popo</dc:creator>
  <cp:lastModifiedBy>kenpopo</cp:lastModifiedBy>
  <cp:revision>133</cp:revision>
  <cp:lastPrinted>2023-03-22T02:38:43Z</cp:lastPrinted>
  <dcterms:created xsi:type="dcterms:W3CDTF">2022-12-14T01:53:37Z</dcterms:created>
  <dcterms:modified xsi:type="dcterms:W3CDTF">2023-04-25T00:29:48Z</dcterms:modified>
</cp:coreProperties>
</file>